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1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1299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765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6944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1095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6457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1101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1827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559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0020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363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129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5AD0B-7916-46C7-9D8E-A6C02742F927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B6528-635D-4614-8CDC-A32DF850CF9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3228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1178807" y="414216"/>
            <a:ext cx="8962226" cy="6343746"/>
            <a:chOff x="1178807" y="414216"/>
            <a:chExt cx="8962226" cy="6343746"/>
          </a:xfrm>
        </p:grpSpPr>
        <p:sp>
          <p:nvSpPr>
            <p:cNvPr id="2" name="Textfeld 1"/>
            <p:cNvSpPr txBox="1"/>
            <p:nvPr/>
          </p:nvSpPr>
          <p:spPr>
            <a:xfrm>
              <a:off x="1312985" y="6111631"/>
              <a:ext cx="8828048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4 Appendix.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ility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dge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weights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. The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red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graph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orresponds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he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dge estimate in the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, the black graph to the mean edge estimate in the bootstrapped samples and the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ray area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 the 95% confidence interval band from the bootstraps edge weights. 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78807" y="414216"/>
              <a:ext cx="8962226" cy="569741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23657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Philipps-Universität Mar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kas Kirchner</dc:creator>
  <cp:lastModifiedBy>Lukas Kirchner</cp:lastModifiedBy>
  <cp:revision>9</cp:revision>
  <dcterms:created xsi:type="dcterms:W3CDTF">2023-03-21T11:07:38Z</dcterms:created>
  <dcterms:modified xsi:type="dcterms:W3CDTF">2024-02-16T16:47:53Z</dcterms:modified>
</cp:coreProperties>
</file>